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3" d="100"/>
          <a:sy n="103" d="100"/>
        </p:scale>
        <p:origin x="-113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8050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59696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68962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13485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34929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58961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80170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2083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3944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66514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65337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098F6-87E5-4C94-9E93-EC53C00AFB80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6360E5-8242-4661-B310-170CCAA811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278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83568" y="258618"/>
            <a:ext cx="5504874" cy="5690662"/>
            <a:chOff x="1653308" y="258618"/>
            <a:chExt cx="5504874" cy="569066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66" t="4225" r="13907" b="6127"/>
            <a:stretch/>
          </p:blipFill>
          <p:spPr bwMode="auto">
            <a:xfrm>
              <a:off x="1653309" y="258618"/>
              <a:ext cx="5504873" cy="5486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66" t="95109" r="13907" b="1118"/>
            <a:stretch/>
          </p:blipFill>
          <p:spPr bwMode="auto">
            <a:xfrm>
              <a:off x="1653308" y="5718370"/>
              <a:ext cx="5504873" cy="2309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5" name="TextBox 4"/>
          <p:cNvSpPr txBox="1"/>
          <p:nvPr/>
        </p:nvSpPr>
        <p:spPr>
          <a:xfrm>
            <a:off x="4283968" y="188640"/>
            <a:ext cx="4608512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Abbreviations: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 AI=Aridity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index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ASP=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Aspect, DTR=Mean diurnal temperature range, ELV=Mean Elevation,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HF=Global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human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footprint,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HNP=Human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appropriation of net primary productivity,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IST=</a:t>
            </a:r>
            <a:r>
              <a:rPr lang="en-IN" sz="1200" dirty="0" err="1" smtClean="0">
                <a:latin typeface="Times New Roman" pitchFamily="18" charset="0"/>
                <a:cs typeface="Times New Roman" pitchFamily="18" charset="0"/>
              </a:rPr>
              <a:t>Isothermality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, MAT=Mean annual </a:t>
            </a:r>
            <a:r>
              <a:rPr lang="en-IN" sz="1200" dirty="0" err="1" smtClean="0">
                <a:latin typeface="Times New Roman" pitchFamily="18" charset="0"/>
                <a:cs typeface="Times New Roman" pitchFamily="18" charset="0"/>
              </a:rPr>
              <a:t>temepearture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, PAN=Annual Precipitation, PCQ=Precipitation of the coldest quarter, PDRM=Precipitation of the driest month, PDR=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Precipitation of driest quarter, PET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= Potential evapotranspiration,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PS=Precipitation Seasonality, PWEM=Precipitation of the wettest month, PWEQ=Precipitation of the wettest quarter, PWMQ=Precipitation of the warmest quarter, SLP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= Slope,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TAR=Temperature annual range, TCM=Temperature of the coldest month, TCQ=Temperature of the coldest quarter, TCQ=Temperature of the driest quarter, TRI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= Terrain ruggedness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index, TS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= Temperature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seasonality, TWEQ=Temperature of the wettest quarter, TWEM=Temperature of the wettest month, TWMQ=Temperature of the warmest quarter,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979713" y="2492896"/>
            <a:ext cx="144015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IN" sz="700" dirty="0"/>
          </a:p>
        </p:txBody>
      </p:sp>
      <p:sp>
        <p:nvSpPr>
          <p:cNvPr id="7" name="Rectangle 6"/>
          <p:cNvSpPr/>
          <p:nvPr/>
        </p:nvSpPr>
        <p:spPr>
          <a:xfrm>
            <a:off x="1043608" y="5933193"/>
            <a:ext cx="51452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igure S1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Correlation </a:t>
            </a:r>
            <a:r>
              <a:rPr lang="en-I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lot of  variables; 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colour and size of circles represent the strength of correlation between each variables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66008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57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MP</dc:creator>
  <cp:lastModifiedBy>RMP</cp:lastModifiedBy>
  <cp:revision>8</cp:revision>
  <dcterms:created xsi:type="dcterms:W3CDTF">2017-05-24T05:54:47Z</dcterms:created>
  <dcterms:modified xsi:type="dcterms:W3CDTF">2017-05-24T06:15:10Z</dcterms:modified>
</cp:coreProperties>
</file>